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56" r:id="rId5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E6FE1"/>
    <a:srgbClr val="6FB872"/>
    <a:srgbClr val="90CC92"/>
    <a:srgbClr val="1C971D"/>
    <a:srgbClr val="F9696A"/>
    <a:srgbClr val="FBBCBD"/>
    <a:srgbClr val="ABC2E2"/>
    <a:srgbClr val="5A8AC6"/>
    <a:srgbClr val="FA696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09"/>
    <p:restoredTop sz="91479"/>
  </p:normalViewPr>
  <p:slideViewPr>
    <p:cSldViewPr snapToGrid="0">
      <p:cViewPr>
        <p:scale>
          <a:sx n="102" d="100"/>
          <a:sy n="102" d="100"/>
        </p:scale>
        <p:origin x="2016" y="-16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chel Edwards" userId="9526a979-b0ff-461c-b936-05f0a0158e0f" providerId="ADAL" clId="{2DD3A273-1982-5533-9227-0D0CACCC622C}"/>
    <pc:docChg chg="custSel modSld">
      <pc:chgData name="Rachel Edwards" userId="9526a979-b0ff-461c-b936-05f0a0158e0f" providerId="ADAL" clId="{2DD3A273-1982-5533-9227-0D0CACCC622C}" dt="2025-10-15T19:03:34.037" v="78" actId="20577"/>
      <pc:docMkLst>
        <pc:docMk/>
      </pc:docMkLst>
      <pc:sldChg chg="delSp modSp mod">
        <pc:chgData name="Rachel Edwards" userId="9526a979-b0ff-461c-b936-05f0a0158e0f" providerId="ADAL" clId="{2DD3A273-1982-5533-9227-0D0CACCC622C}" dt="2025-10-15T19:03:34.037" v="78" actId="20577"/>
        <pc:sldMkLst>
          <pc:docMk/>
          <pc:sldMk cId="1728074130" sldId="256"/>
        </pc:sldMkLst>
        <pc:spChg chg="mod">
          <ac:chgData name="Rachel Edwards" userId="9526a979-b0ff-461c-b936-05f0a0158e0f" providerId="ADAL" clId="{2DD3A273-1982-5533-9227-0D0CACCC622C}" dt="2025-10-15T19:03:34.037" v="78" actId="20577"/>
          <ac:spMkLst>
            <pc:docMk/>
            <pc:sldMk cId="1728074130" sldId="256"/>
            <ac:spMk id="4" creationId="{BC012FBB-2DAE-105D-7E58-0ECCA1887C31}"/>
          </ac:spMkLst>
        </pc:spChg>
        <pc:spChg chg="mod">
          <ac:chgData name="Rachel Edwards" userId="9526a979-b0ff-461c-b936-05f0a0158e0f" providerId="ADAL" clId="{2DD3A273-1982-5533-9227-0D0CACCC622C}" dt="2025-10-13T18:29:52.040" v="39" actId="1035"/>
          <ac:spMkLst>
            <pc:docMk/>
            <pc:sldMk cId="1728074130" sldId="256"/>
            <ac:spMk id="14" creationId="{981D634D-BD06-60E1-6521-D4540215D920}"/>
          </ac:spMkLst>
        </pc:spChg>
        <pc:spChg chg="mod">
          <ac:chgData name="Rachel Edwards" userId="9526a979-b0ff-461c-b936-05f0a0158e0f" providerId="ADAL" clId="{2DD3A273-1982-5533-9227-0D0CACCC622C}" dt="2025-10-13T18:29:52.040" v="39" actId="1035"/>
          <ac:spMkLst>
            <pc:docMk/>
            <pc:sldMk cId="1728074130" sldId="256"/>
            <ac:spMk id="21" creationId="{EF904036-C9D7-CEA7-1B25-904E221B811D}"/>
          </ac:spMkLst>
        </pc:spChg>
        <pc:spChg chg="mod">
          <ac:chgData name="Rachel Edwards" userId="9526a979-b0ff-461c-b936-05f0a0158e0f" providerId="ADAL" clId="{2DD3A273-1982-5533-9227-0D0CACCC622C}" dt="2025-10-13T18:29:52.040" v="39" actId="1035"/>
          <ac:spMkLst>
            <pc:docMk/>
            <pc:sldMk cId="1728074130" sldId="256"/>
            <ac:spMk id="23" creationId="{A55C0997-D659-FDD2-45D6-F0D1221EDDC7}"/>
          </ac:spMkLst>
        </pc:spChg>
        <pc:spChg chg="mod">
          <ac:chgData name="Rachel Edwards" userId="9526a979-b0ff-461c-b936-05f0a0158e0f" providerId="ADAL" clId="{2DD3A273-1982-5533-9227-0D0CACCC622C}" dt="2025-10-13T18:29:52.040" v="39" actId="1035"/>
          <ac:spMkLst>
            <pc:docMk/>
            <pc:sldMk cId="1728074130" sldId="256"/>
            <ac:spMk id="25" creationId="{6BEB4CFA-6031-CC54-A9F8-9D152A405F8A}"/>
          </ac:spMkLst>
        </pc:spChg>
        <pc:spChg chg="mod">
          <ac:chgData name="Rachel Edwards" userId="9526a979-b0ff-461c-b936-05f0a0158e0f" providerId="ADAL" clId="{2DD3A273-1982-5533-9227-0D0CACCC622C}" dt="2025-10-13T18:29:52.040" v="39" actId="1035"/>
          <ac:spMkLst>
            <pc:docMk/>
            <pc:sldMk cId="1728074130" sldId="256"/>
            <ac:spMk id="26" creationId="{CD4B7103-09CC-A5AD-DD65-7F9ECAB172CB}"/>
          </ac:spMkLst>
        </pc:spChg>
        <pc:picChg chg="mod">
          <ac:chgData name="Rachel Edwards" userId="9526a979-b0ff-461c-b936-05f0a0158e0f" providerId="ADAL" clId="{2DD3A273-1982-5533-9227-0D0CACCC622C}" dt="2025-10-13T18:29:52.040" v="39" actId="1035"/>
          <ac:picMkLst>
            <pc:docMk/>
            <pc:sldMk cId="1728074130" sldId="256"/>
            <ac:picMk id="5" creationId="{68395960-CB31-E996-58AC-FBE12CDCC7F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0A6CF9-E2FC-9046-8967-39F09EC4F788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F9FA02-4D04-9549-BFE4-4F65DD354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2591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F9FA02-4D04-9549-BFE4-4F65DD35421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5412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049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264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056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165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139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186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517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96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740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3781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325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6F929C-A6AA-C045-B551-425F7B6CF004}" type="datetimeFigureOut">
              <a:rPr lang="en-US" smtClean="0"/>
              <a:t>10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810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C012FBB-2DAE-105D-7E58-0ECCA1887C31}"/>
              </a:ext>
            </a:extLst>
          </p:cNvPr>
          <p:cNvSpPr txBox="1"/>
          <p:nvPr/>
        </p:nvSpPr>
        <p:spPr>
          <a:xfrm>
            <a:off x="933023" y="5436918"/>
            <a:ext cx="418219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/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Fold changes </a:t>
            </a:r>
            <a:r>
              <a:rPr lang="en-US" sz="12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the e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olved </a:t>
            </a:r>
            <a:r>
              <a:rPr lang="en-US" sz="1200" b="1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lS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ariants showing improved </a:t>
            </a:r>
            <a:r>
              <a:rPr lang="en-US" sz="1200" b="1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ase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ctivity for the GBSV glycan.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ld changes comparing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lS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ariants to the respective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lS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ldtype controls are displayed as means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±</a:t>
            </a:r>
            <a:r>
              <a:rPr lang="en-US" sz="1200" dirty="0">
                <a:effectLst/>
              </a:rPr>
              <a:t>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D from at least 3 independent experiments. Dashed line indicates the 1.0-fold threshold set for the wildtype controls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55C0997-D659-FDD2-45D6-F0D1221EDDC7}"/>
              </a:ext>
            </a:extLst>
          </p:cNvPr>
          <p:cNvSpPr txBox="1"/>
          <p:nvPr/>
        </p:nvSpPr>
        <p:spPr>
          <a:xfrm>
            <a:off x="2297438" y="120946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.8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BEB4CFA-6031-CC54-A9F8-9D152A405F8A}"/>
              </a:ext>
            </a:extLst>
          </p:cNvPr>
          <p:cNvSpPr txBox="1"/>
          <p:nvPr/>
        </p:nvSpPr>
        <p:spPr>
          <a:xfrm>
            <a:off x="3636417" y="135465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.7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D4B7103-09CC-A5AD-DD65-7F9ECAB172CB}"/>
              </a:ext>
            </a:extLst>
          </p:cNvPr>
          <p:cNvSpPr txBox="1"/>
          <p:nvPr/>
        </p:nvSpPr>
        <p:spPr>
          <a:xfrm>
            <a:off x="4317919" y="72140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.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81D634D-BD06-60E1-6521-D4540215D920}"/>
              </a:ext>
            </a:extLst>
          </p:cNvPr>
          <p:cNvSpPr txBox="1"/>
          <p:nvPr/>
        </p:nvSpPr>
        <p:spPr>
          <a:xfrm>
            <a:off x="1619663" y="296093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F904036-C9D7-CEA7-1B25-904E221B811D}"/>
              </a:ext>
            </a:extLst>
          </p:cNvPr>
          <p:cNvSpPr txBox="1"/>
          <p:nvPr/>
        </p:nvSpPr>
        <p:spPr>
          <a:xfrm>
            <a:off x="2969255" y="296093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8395960-CB31-E996-58AC-FBE12CDCC7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8055" y="604389"/>
            <a:ext cx="4191023" cy="47954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8074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8E8871314C8434FB52206FC0D75AEC5" ma:contentTypeVersion="15" ma:contentTypeDescription="Create a new document." ma:contentTypeScope="" ma:versionID="9669befa45aa3885246f648b2dbc40ad">
  <xsd:schema xmlns:xsd="http://www.w3.org/2001/XMLSchema" xmlns:xs="http://www.w3.org/2001/XMLSchema" xmlns:p="http://schemas.microsoft.com/office/2006/metadata/properties" xmlns:ns2="324db12f-297c-40e3-86f6-4d82186512ff" xmlns:ns3="28e55284-abd9-4569-8d7b-f719476aa490" targetNamespace="http://schemas.microsoft.com/office/2006/metadata/properties" ma:root="true" ma:fieldsID="82e65c3b09da1b7f028bd4253ea4a73e" ns2:_="" ns3:_="">
    <xsd:import namespace="324db12f-297c-40e3-86f6-4d82186512ff"/>
    <xsd:import namespace="28e55284-abd9-4569-8d7b-f719476aa490"/>
    <xsd:element name="properties">
      <xsd:complexType>
        <xsd:sequence>
          <xsd:element name="documentManagement">
            <xsd:complexType>
              <xsd:all>
                <xsd:element ref="ns2:MigrationWizId" minOccurs="0"/>
                <xsd:element ref="ns2:MigrationWizIdPermissions" minOccurs="0"/>
                <xsd:element ref="ns2:MigrationWizIdVersion" minOccurs="0"/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4db12f-297c-40e3-86f6-4d82186512ff" elementFormDefault="qualified">
    <xsd:import namespace="http://schemas.microsoft.com/office/2006/documentManagement/types"/>
    <xsd:import namespace="http://schemas.microsoft.com/office/infopath/2007/PartnerControls"/>
    <xsd:element name="MigrationWizId" ma:index="8" nillable="true" ma:displayName="MigrationWizId" ma:internalName="MigrationWizId">
      <xsd:simpleType>
        <xsd:restriction base="dms:Text"/>
      </xsd:simpleType>
    </xsd:element>
    <xsd:element name="MigrationWizIdPermissions" ma:index="9" nillable="true" ma:displayName="MigrationWizIdPermissions" ma:internalName="MigrationWizIdPermissions">
      <xsd:simpleType>
        <xsd:restriction base="dms:Text"/>
      </xsd:simpleType>
    </xsd:element>
    <xsd:element name="MigrationWizIdVersion" ma:index="10" nillable="true" ma:displayName="MigrationWizIdVersion" ma:internalName="MigrationWizIdVersion">
      <xsd:simpleType>
        <xsd:restriction base="dms:Text"/>
      </xsd:simpleType>
    </xsd:element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6ac3562-be2b-463b-9688-fb9859eb15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8e55284-abd9-4569-8d7b-f719476aa490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652b7d07-4398-489a-9ec2-57654188717d}" ma:internalName="TaxCatchAll" ma:showField="CatchAllData" ma:web="28e55284-abd9-4569-8d7b-f719476aa49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MigrationWizIdVersion xmlns="324db12f-297c-40e3-86f6-4d82186512ff" xsi:nil="true"/>
    <lcf76f155ced4ddcb4097134ff3c332f xmlns="324db12f-297c-40e3-86f6-4d82186512ff">
      <Terms xmlns="http://schemas.microsoft.com/office/infopath/2007/PartnerControls"/>
    </lcf76f155ced4ddcb4097134ff3c332f>
    <MigrationWizIdPermissions xmlns="324db12f-297c-40e3-86f6-4d82186512ff" xsi:nil="true"/>
    <MigrationWizId xmlns="324db12f-297c-40e3-86f6-4d82186512ff" xsi:nil="true"/>
    <TaxCatchAll xmlns="28e55284-abd9-4569-8d7b-f719476aa490" xsi:nil="true"/>
  </documentManagement>
</p:properties>
</file>

<file path=customXml/itemProps1.xml><?xml version="1.0" encoding="utf-8"?>
<ds:datastoreItem xmlns:ds="http://schemas.openxmlformats.org/officeDocument/2006/customXml" ds:itemID="{3C266E1B-37D4-4821-8E8A-14EBBE40F63F}"/>
</file>

<file path=customXml/itemProps2.xml><?xml version="1.0" encoding="utf-8"?>
<ds:datastoreItem xmlns:ds="http://schemas.openxmlformats.org/officeDocument/2006/customXml" ds:itemID="{8298FA59-125D-4B68-9F86-AFF3E7138A0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A66AEF5-C7C5-4E8D-AC56-C5247E4D2026}">
  <ds:schemaRefs>
    <ds:schemaRef ds:uri="http://purl.org/dc/elements/1.1/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http://schemas.microsoft.com/office/2006/documentManagement/types"/>
    <ds:schemaRef ds:uri="28e55284-abd9-4569-8d7b-f719476aa490"/>
    <ds:schemaRef ds:uri="324db12f-297c-40e3-86f6-4d82186512ff"/>
    <ds:schemaRef ds:uri="http://schemas.microsoft.com/office/2006/metadata/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9</TotalTime>
  <Words>61</Words>
  <Application>Microsoft Macintosh PowerPoint</Application>
  <PresentationFormat>A3 Paper (297x420 mm)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chel Edwards</dc:creator>
  <cp:lastModifiedBy>Rachel Edwards</cp:lastModifiedBy>
  <cp:revision>2</cp:revision>
  <dcterms:created xsi:type="dcterms:W3CDTF">2025-01-22T18:46:44Z</dcterms:created>
  <dcterms:modified xsi:type="dcterms:W3CDTF">2025-10-15T19:03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8E8871314C8434FB52206FC0D75AEC5</vt:lpwstr>
  </property>
</Properties>
</file>